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howGuides="1">
      <p:cViewPr varScale="1">
        <p:scale>
          <a:sx n="108" d="100"/>
          <a:sy n="108" d="100"/>
        </p:scale>
        <p:origin x="678" y="10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4B6F86-E59B-498D-9D4B-BA10CC07A4E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15919B2-E0A8-42EE-8000-601B4CDCB2E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9E189BB-8193-47E7-820A-86D1CE896F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BA276B-2F51-4B1B-871A-D28520C495CA}" type="datetimeFigureOut">
              <a:rPr lang="en-US" smtClean="0"/>
              <a:t>1/1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60A3905-4B1F-49AE-B8D8-B49745F7F1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02CFE3C-83AD-4F59-9398-9BF93040A8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2AF58-917F-40F6-B8FE-34881E531F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45359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6DF30B-3B6B-4E64-B4E2-3BCF2222BF6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4B32385-B89C-411C-9A4E-EAA6CC56D53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EA34BAB-7897-4395-BAFE-16609CC9A2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BA276B-2F51-4B1B-871A-D28520C495CA}" type="datetimeFigureOut">
              <a:rPr lang="en-US" smtClean="0"/>
              <a:t>1/1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9254F26-72EE-4A87-91B4-1CFD60C0F4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8334B59-A0DF-4131-BE7A-3AE221A622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2AF58-917F-40F6-B8FE-34881E531F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83214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EF44CFF-5C5C-4782-92E9-72EED57CB5E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B70CE6E-2181-478A-8589-8FE0CE3CBF9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9A53EBC-C6DE-4000-B6C9-7BE9F23A5B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BA276B-2F51-4B1B-871A-D28520C495CA}" type="datetimeFigureOut">
              <a:rPr lang="en-US" smtClean="0"/>
              <a:t>1/1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CB30893-756A-4797-825D-B1AC475004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4255E5B-5B65-40F6-922D-A87F18A7CB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2AF58-917F-40F6-B8FE-34881E531F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55509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03E94A-8BB3-450D-AB00-B22C62C2CA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A827A2D-64C4-4350-AB71-160E3E4C74D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CCFC1C0-801B-4280-A767-66A103C3AE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BA276B-2F51-4B1B-871A-D28520C495CA}" type="datetimeFigureOut">
              <a:rPr lang="en-US" smtClean="0"/>
              <a:t>1/1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C9672D5-1D2A-43B7-BB53-201003E873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B0A4E7C-E90B-46D2-8B52-11EFEE811C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2AF58-917F-40F6-B8FE-34881E531F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24621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8AA5D3B-4AAD-40CF-ABE9-47E3E00F7D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FA97BC8-2BD0-47CF-962E-DFA69053945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BFF7826-DFC7-45F7-83BA-492BBD8BCB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BA276B-2F51-4B1B-871A-D28520C495CA}" type="datetimeFigureOut">
              <a:rPr lang="en-US" smtClean="0"/>
              <a:t>1/1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6A6E593-8466-4FAE-A871-B5FE2F6806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5C77A69-EF5C-48BA-8CD5-DAA6900806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2AF58-917F-40F6-B8FE-34881E531F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16750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4A2B939-9EE6-475A-B1C6-B7A6F92DB5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E709B4E-24FD-4793-BF76-4DC7005A306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4948E18-FF47-455B-98B8-272B164F0D4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70895B6-1E04-40B3-BF82-487A1A040B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BA276B-2F51-4B1B-871A-D28520C495CA}" type="datetimeFigureOut">
              <a:rPr lang="en-US" smtClean="0"/>
              <a:t>1/1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5F94FB8-1E92-4FA3-8FC3-4171D23123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B660985-CF57-4A90-9860-4E7445AA00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2AF58-917F-40F6-B8FE-34881E531F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24821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F96CA2-C740-4E9B-A556-5ADEF4452F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5919ABE-B54D-4BA6-940B-6F41B6B70AC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6115960-2455-425B-B70C-7C8F20483C0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B56F2A0-CA32-4E8F-8EC7-F224649FED4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2907391-2F78-4242-B8BF-E51B41B6B91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F12C9D8-DA34-43D8-A8FE-195A61E673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BA276B-2F51-4B1B-871A-D28520C495CA}" type="datetimeFigureOut">
              <a:rPr lang="en-US" smtClean="0"/>
              <a:t>1/1/2019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4F2500B-D1CC-492A-B33F-6A5BE529F5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7E5B675-406F-41CB-B730-EA9B83F271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2AF58-917F-40F6-B8FE-34881E531F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39870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07ACC93-9CFC-43D4-86DE-7423A814002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D788462-D85C-4378-9707-E286D616B8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BA276B-2F51-4B1B-871A-D28520C495CA}" type="datetimeFigureOut">
              <a:rPr lang="en-US" smtClean="0"/>
              <a:t>1/1/2019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3BA981E-78DC-4B3A-929C-631C2735B2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C2DE450-89B7-46D4-9004-924D52FEE1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2AF58-917F-40F6-B8FE-34881E531F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60701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B0AB7A3-A817-4AC2-A2C7-1B9C0A24F2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BA276B-2F51-4B1B-871A-D28520C495CA}" type="datetimeFigureOut">
              <a:rPr lang="en-US" smtClean="0"/>
              <a:t>1/1/2019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2756957-5E14-47EF-B5DA-A187BE681E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3180329-61BC-415C-9CBD-B27BB83572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2AF58-917F-40F6-B8FE-34881E531F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91284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C95FEC-A4E5-48E3-A519-BABB897C17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94AC572-4A5D-4F6F-9E7E-00CADC3CF69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66F0457-642B-493A-A3CE-986239E8CC2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2F68A10-FEBD-40E9-9CAC-383E46C74C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BA276B-2F51-4B1B-871A-D28520C495CA}" type="datetimeFigureOut">
              <a:rPr lang="en-US" smtClean="0"/>
              <a:t>1/1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1DEECE2-45A5-4960-95DC-C14EAB0C41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F3A619E-A2F5-4AE7-A0D6-EE0EAFF5B6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2AF58-917F-40F6-B8FE-34881E531F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19264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A92DC1-7967-44ED-8213-375352EF39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A8FB80F-461A-43EB-8707-D257E0086E1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BB39ABC-F1EB-4284-B693-36DA1755AA7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8F43689-27C0-4AF7-B9F6-212D676E58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BA276B-2F51-4B1B-871A-D28520C495CA}" type="datetimeFigureOut">
              <a:rPr lang="en-US" smtClean="0"/>
              <a:t>1/1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E924106-17CB-4DFC-8DC8-3A2411AAA3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4F7675C-7A8D-41DD-8534-596890BEBA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2AF58-917F-40F6-B8FE-34881E531F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913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F7E9C29-4D03-43DF-81F6-751BC66E908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B03D461-1626-42AB-9CAF-392199C0155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AAB6239-E801-4089-8876-00A6CCFB7AC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BA276B-2F51-4B1B-871A-D28520C495CA}" type="datetimeFigureOut">
              <a:rPr lang="en-US" smtClean="0"/>
              <a:t>1/1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3E2E074-67DB-4C96-A0C7-02D70E2AB1E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1D50EC8-C483-42D3-BA66-2A21DE4F0ED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02AF58-917F-40F6-B8FE-34881E531F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99086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0B6519-796C-42B6-BA1B-6D0413AFBC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0"/>
            <a:ext cx="12188952" cy="914400"/>
          </a:xfrm>
        </p:spPr>
        <p:txBody>
          <a:bodyPr>
            <a:norm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catter plots and Pearson’s correlation coefficients of methylation M-values of top ten age-associated differentially methylated CpG positions (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DMPs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chronological age in (a) African Americans and (b) whites.  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B2BB0A6D-449F-4B37-9B37-6333695ABF76}"/>
              </a:ext>
            </a:extLst>
          </p:cNvPr>
          <p:cNvSpPr txBox="1"/>
          <p:nvPr/>
        </p:nvSpPr>
        <p:spPr>
          <a:xfrm>
            <a:off x="457200" y="914400"/>
            <a:ext cx="4539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  <p:pic>
        <p:nvPicPr>
          <p:cNvPr id="6" name="Content Placeholder 5" descr="A close up of a map&#10;&#10;Description automatically generated">
            <a:extLst>
              <a:ext uri="{FF2B5EF4-FFF2-40B4-BE49-F238E27FC236}">
                <a16:creationId xmlns:a16="http://schemas.microsoft.com/office/drawing/2014/main" id="{A1683167-D3A3-4930-8718-C4F2B2B8F5A0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71600" y="914400"/>
            <a:ext cx="9448800" cy="5669280"/>
          </a:xfrm>
        </p:spPr>
      </p:pic>
    </p:spTree>
    <p:extLst>
      <p:ext uri="{BB962C8B-B14F-4D97-AF65-F5344CB8AC3E}">
        <p14:creationId xmlns:p14="http://schemas.microsoft.com/office/powerpoint/2010/main" val="321495132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0B6519-796C-42B6-BA1B-6D0413AFBC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0"/>
            <a:ext cx="12188952" cy="914400"/>
          </a:xfrm>
        </p:spPr>
        <p:txBody>
          <a:bodyPr>
            <a:norm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ntinued.  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B2BB0A6D-449F-4B37-9B37-6333695ABF76}"/>
              </a:ext>
            </a:extLst>
          </p:cNvPr>
          <p:cNvSpPr txBox="1"/>
          <p:nvPr/>
        </p:nvSpPr>
        <p:spPr>
          <a:xfrm>
            <a:off x="457200" y="914400"/>
            <a:ext cx="4667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  <p:pic>
        <p:nvPicPr>
          <p:cNvPr id="5" name="Content Placeholder 4" descr="A close up of a map&#10;&#10;Description automatically generated">
            <a:extLst>
              <a:ext uri="{FF2B5EF4-FFF2-40B4-BE49-F238E27FC236}">
                <a16:creationId xmlns:a16="http://schemas.microsoft.com/office/drawing/2014/main" id="{C5FE5790-67C2-47E2-B976-A612C0FC3170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71600" y="914400"/>
            <a:ext cx="9448800" cy="5669280"/>
          </a:xfrm>
        </p:spPr>
      </p:pic>
    </p:spTree>
    <p:extLst>
      <p:ext uri="{BB962C8B-B14F-4D97-AF65-F5344CB8AC3E}">
        <p14:creationId xmlns:p14="http://schemas.microsoft.com/office/powerpoint/2010/main" val="28945510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2</TotalTime>
  <Words>49</Words>
  <Application>Microsoft Office PowerPoint</Application>
  <PresentationFormat>Widescreen</PresentationFormat>
  <Paragraphs>4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Figure S2. Scatter plots and Pearson’s correlation coefficients of methylation M-values of top ten age-associated differentially methylated CpG positions (aDMPs) and chronological age in (a) African Americans and (b) whites.  </vt:lpstr>
      <vt:lpstr>Figure S2. continued.  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ajuddin, Salman (NIH/NIA/IRP) [F]</dc:creator>
  <cp:lastModifiedBy>Tajuddin, Salman (NIH/NIA/IRP) [F]</cp:lastModifiedBy>
  <cp:revision>20</cp:revision>
  <dcterms:created xsi:type="dcterms:W3CDTF">2018-08-05T17:31:02Z</dcterms:created>
  <dcterms:modified xsi:type="dcterms:W3CDTF">2019-01-02T04:03:41Z</dcterms:modified>
</cp:coreProperties>
</file>